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-102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80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13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044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536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976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750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18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116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616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053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24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DDD30-BB8A-4185-9E8E-F524FDDA9691}" type="datetimeFigureOut">
              <a:rPr lang="en-US" smtClean="0"/>
              <a:t>5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CAE787-F96B-4825-B440-FB62510D52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32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381000" y="381000"/>
          <a:ext cx="7086600" cy="2228850"/>
        </p:xfrm>
        <a:graphic>
          <a:graphicData uri="http://schemas.openxmlformats.org/drawingml/2006/table">
            <a:tbl>
              <a:tblPr firstRow="1" firstCol="1">
                <a:tableStyleId>{5C22544A-7EE6-4342-B048-85BDC9FD1C3A}</a:tableStyleId>
              </a:tblPr>
              <a:tblGrid>
                <a:gridCol w="93181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37831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41427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3622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1759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Symbo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Gene I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Forward Prim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Reverse Prim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TIN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A10g03990</a:t>
                      </a:r>
                      <a:endParaRPr lang="en-US" sz="1400" b="0" i="0" u="none" strike="noStrike" dirty="0">
                        <a:solidFill>
                          <a:srgbClr val="333333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GGGCTTATGGGCAGTGGTTA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GGCCCATTCAAACATGGAC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WRKY2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A02g14640</a:t>
                      </a:r>
                      <a:endParaRPr lang="en-US" sz="1400" b="0" i="0" u="none" strike="noStrike" dirty="0">
                        <a:solidFill>
                          <a:srgbClr val="333333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GTTGACAGGGGATACGGAG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GACAACGGAGGCTTTCCAG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FA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A08g04180</a:t>
                      </a:r>
                      <a:endParaRPr lang="en-US" sz="1400" b="0" i="0" u="none" strike="noStrike" dirty="0">
                        <a:solidFill>
                          <a:srgbClr val="333333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TGTTGAACCACACTCACGC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GTTGCCTCGACTGCATGGTA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CaCRF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A06g25980</a:t>
                      </a:r>
                      <a:endParaRPr lang="en-US" sz="1400" b="0" i="0" u="none" strike="noStrike" dirty="0">
                        <a:solidFill>
                          <a:srgbClr val="333333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TCATTCTTTCGGTTGCCGGA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GCCTCAAGGGCAAAATCGT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AI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A04g13560 </a:t>
                      </a:r>
                      <a:endParaRPr lang="en-US" sz="1400" b="0" i="0" u="none" strike="noStrike" dirty="0">
                        <a:solidFill>
                          <a:srgbClr val="333333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AGCAAAGCTACGTCTTGCC</a:t>
                      </a:r>
                      <a:endParaRPr lang="en-US" sz="1400" b="0" i="0" u="none" strike="noStrike" dirty="0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GTCCCATTTGAGCTTCCATGC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759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PIP1</a:t>
                      </a:r>
                      <a:endParaRPr lang="en-US" sz="1400" b="1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CA02g112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CAGAATAATGGCGGGGGC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GTGCTGCAAACACTTTGACC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75947"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3245089459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CT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00g80270</a:t>
                      </a:r>
                      <a:endParaRPr lang="en-US" sz="1400" b="0" i="0" u="none" strike="noStrike">
                        <a:solidFill>
                          <a:srgbClr val="333333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TGGATTTGCTGGTGATGATG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TCCTTTTGACCCATCCCT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076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FRLP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06g0374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GGGAAAGTTGAAGATGCCG</a:t>
                      </a:r>
                      <a:endParaRPr lang="en-US" sz="1400" b="0" i="0" u="none" strike="noStrike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CTCCTTGCTCTATCCACTTG</a:t>
                      </a:r>
                      <a:endParaRPr lang="en-US" sz="1400" b="0" i="0" u="none" strike="noStrike" dirty="0">
                        <a:solidFill>
                          <a:srgbClr val="222222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381000" y="2743200"/>
            <a:ext cx="70789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/>
              <a:t>Supplemental Table </a:t>
            </a:r>
            <a:r>
              <a:rPr lang="en-US" sz="1600" b="1" dirty="0"/>
              <a:t>4. </a:t>
            </a:r>
            <a:r>
              <a:rPr lang="en-US" sz="1600" b="1" dirty="0" smtClean="0"/>
              <a:t>qPCR Primer Sequences. </a:t>
            </a:r>
            <a:r>
              <a:rPr lang="en-US" sz="1600" dirty="0" smtClean="0"/>
              <a:t>Forward and reverse primers used for DEG confirmation </a:t>
            </a:r>
            <a:r>
              <a:rPr lang="en-US" sz="1600" dirty="0"/>
              <a:t>of RNA sequencing </a:t>
            </a:r>
            <a:r>
              <a:rPr lang="en-US" sz="1600" dirty="0" smtClean="0"/>
              <a:t>transcriptomic </a:t>
            </a:r>
            <a:r>
              <a:rPr lang="en-US" sz="1600" dirty="0"/>
              <a:t>results. </a:t>
            </a:r>
            <a:r>
              <a:rPr lang="en-US" sz="1600" dirty="0" smtClean="0"/>
              <a:t>Gene symbol and ID are shown along with the two control genes FRLP and ACT2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086661020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Theme1" id="{E516DD92-744D-416C-8402-47CFD9AFCB01}" vid="{D95DABE9-426B-4C13-BE09-35857C3401C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0</TotalTime>
  <Words>77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eme1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Rashotte</dc:creator>
  <cp:lastModifiedBy>John F. Murphy</cp:lastModifiedBy>
  <cp:revision>2</cp:revision>
  <dcterms:created xsi:type="dcterms:W3CDTF">2018-12-17T20:15:11Z</dcterms:created>
  <dcterms:modified xsi:type="dcterms:W3CDTF">2019-05-12T15:54:04Z</dcterms:modified>
</cp:coreProperties>
</file>